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76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560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20520" y="745920"/>
            <a:ext cx="4965480" cy="3725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560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D1D88D-B3E0-4468-A578-8CECFC8F668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920880" y="746280"/>
            <a:ext cx="4965480" cy="372564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スライド番号プレースホル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C75E1A-7486-4343-80B9-243D0D79547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920880" y="746280"/>
            <a:ext cx="4965480" cy="372564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スライド番号プレースホル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943DE0-288E-4149-8F6D-1F000E9997E6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523F7-1CF3-4DA3-9F59-BA31E3BB46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E12F4-67A0-4731-ADE5-2F85A0725C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59F9A-BA52-4D69-8F21-DF6BDF909F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BC61A2-3233-46D9-8AB6-91F23AF0AE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DFBFE-833C-4929-BC39-06EC317553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C99E6-E229-42EA-AB39-51C06D8915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B4689-60F5-4B0C-A4A1-729C347EC2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AF092-4D37-466F-B434-566A2848C8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C6B5D-2754-43F7-8248-4567D2B639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9425B-131D-476A-8B8D-20002422EA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610B6-E6E7-405E-B3ED-A8298A858D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9551E-3D0F-43B2-AE95-9AC342B6C6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C7CE4E-E3D7-4363-AF85-E27489B8DBE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1"/>
          <p:cNvSpPr/>
          <p:nvPr/>
        </p:nvSpPr>
        <p:spPr>
          <a:xfrm>
            <a:off x="1395360" y="1989000"/>
            <a:ext cx="55436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Calibri"/>
              </a:rPr>
              <a:t>Additional file 7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2"/>
          <p:cNvSpPr/>
          <p:nvPr/>
        </p:nvSpPr>
        <p:spPr>
          <a:xfrm>
            <a:off x="1395360" y="2682720"/>
            <a:ext cx="66960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All the identified proteins of the non-redundant, high-confidence dataset of glomerulus proteome consisting of 1,817 unique proteins representing 1,478 unique genes were analyzed for under-represented or depleted proteins using Cytoscape (version 2.82) in combination with BinGO plug-in (version 2.42). Only terms with hits significantly lower than those of human genes are shown. Statistical significance was assessed as described in the tex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図 4" descr="Depletion analysis_CuiHGL_121212.jpg"/>
          <p:cNvPicPr/>
          <p:nvPr/>
        </p:nvPicPr>
        <p:blipFill>
          <a:blip r:embed="rId1"/>
          <a:stretch/>
        </p:blipFill>
        <p:spPr>
          <a:xfrm>
            <a:off x="0" y="322200"/>
            <a:ext cx="9144000" cy="6213600"/>
          </a:xfrm>
          <a:prstGeom prst="rect">
            <a:avLst/>
          </a:prstGeom>
          <a:ln w="0">
            <a:noFill/>
          </a:ln>
        </p:spPr>
      </p:pic>
      <p:pic>
        <p:nvPicPr>
          <p:cNvPr id="51" name="図 6" descr="Cytoscape color scale.jpg"/>
          <p:cNvPicPr/>
          <p:nvPr/>
        </p:nvPicPr>
        <p:blipFill>
          <a:blip r:embed="rId2"/>
          <a:stretch/>
        </p:blipFill>
        <p:spPr>
          <a:xfrm>
            <a:off x="971640" y="5877000"/>
            <a:ext cx="936360" cy="44748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6"/>
          <p:cNvSpPr/>
          <p:nvPr/>
        </p:nvSpPr>
        <p:spPr>
          <a:xfrm>
            <a:off x="6512040" y="6505560"/>
            <a:ext cx="25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7, Cui et 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2T00:49:20Z</dcterms:created>
  <dc:creator>Yutaka Yoshida</dc:creator>
  <dc:description/>
  <dc:language>en-US</dc:language>
  <cp:lastModifiedBy>Yutaka Yoshida</cp:lastModifiedBy>
  <dcterms:modified xsi:type="dcterms:W3CDTF">2013-03-27T02:58:19Z</dcterms:modified>
  <cp:revision>9</cp:revision>
  <dc:subject/>
  <dc:title>スライド 1</dc:title>
</cp:coreProperties>
</file>